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55519-B5E5-49A4-9B40-8562C8E580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9FBC7-ABA8-4DBF-9D19-9AC68E9D72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AC8742-9491-423D-A812-3097E3FCCC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AE66D-7F01-4FD9-B91C-2B9B5B171F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6AD197-4B73-463C-AB4B-3501F0AA65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0F11C-D6B9-42E7-AA9C-DD44975E59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6A8F7-C484-4A43-8322-F8810E52F1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15184-9493-42C6-A32A-55CCE25AD6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A66A9-956F-4E2E-873D-FA8013B316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FF50E-9493-4A69-A06A-E81689C83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8B59B-D31D-42B2-98EE-F88B84649C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8EE88-D81B-4E9D-B025-DA3D2E87E2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4B212D-02B0-448B-BE2E-D77912920D64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27"/>
          <p:cNvGrpSpPr/>
          <p:nvPr/>
        </p:nvGrpSpPr>
        <p:grpSpPr>
          <a:xfrm>
            <a:off x="972000" y="476280"/>
            <a:ext cx="6840000" cy="4158720"/>
            <a:chOff x="972000" y="476280"/>
            <a:chExt cx="6840000" cy="4158720"/>
          </a:xfrm>
        </p:grpSpPr>
        <p:sp>
          <p:nvSpPr>
            <p:cNvPr id="42" name="Rectangle 50"/>
            <p:cNvSpPr/>
            <p:nvPr/>
          </p:nvSpPr>
          <p:spPr>
            <a:xfrm>
              <a:off x="2093760" y="2097720"/>
              <a:ext cx="28728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I/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51"/>
            <p:cNvSpPr/>
            <p:nvPr/>
          </p:nvSpPr>
          <p:spPr>
            <a:xfrm>
              <a:off x="2868480" y="2097720"/>
              <a:ext cx="2840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A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3"/>
            <p:cNvSpPr/>
            <p:nvPr/>
          </p:nvSpPr>
          <p:spPr>
            <a:xfrm>
              <a:off x="3560040" y="2097720"/>
              <a:ext cx="372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RSV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5" name="Picture 7" descr="C:\Users\dora\Desktop\VALENTINA\2015\Immagini dal ChemiDoc\TIFF 24-03-2015\G1 SIRT1 santa crux  pan cetil p65 lys310 GSK3b 15'  per pan acetul p65.tif"/>
            <p:cNvPicPr/>
            <p:nvPr/>
          </p:nvPicPr>
          <p:blipFill>
            <a:blip r:embed="rId1"/>
            <a:srcRect l="22924" t="21163" r="18175" b="69231"/>
            <a:stretch/>
          </p:blipFill>
          <p:spPr>
            <a:xfrm>
              <a:off x="1557000" y="3089160"/>
              <a:ext cx="3645720" cy="430920"/>
            </a:xfrm>
            <a:prstGeom prst="rect">
              <a:avLst/>
            </a:prstGeom>
            <a:ln w="9360">
              <a:solidFill>
                <a:srgbClr val="7f7f7f"/>
              </a:solidFill>
              <a:miter/>
            </a:ln>
          </p:spPr>
        </p:pic>
        <p:pic>
          <p:nvPicPr>
            <p:cNvPr id="46" name="Picture 4" descr="C:\Users\dora\Desktop\VALENTINA\2015\Immagini dal ChemiDoc\TIFF 27-01-2015\G1 ph-ENOS G2 lys 310 p65 acetil 10'.tif"/>
            <p:cNvPicPr/>
            <p:nvPr/>
          </p:nvPicPr>
          <p:blipFill>
            <a:blip r:embed="rId2"/>
            <a:srcRect l="22665" t="38462" r="32795" b="53856"/>
            <a:stretch/>
          </p:blipFill>
          <p:spPr>
            <a:xfrm>
              <a:off x="1704600" y="1099800"/>
              <a:ext cx="2526840" cy="316080"/>
            </a:xfrm>
            <a:prstGeom prst="rect">
              <a:avLst/>
            </a:prstGeom>
            <a:ln w="9360">
              <a:solidFill>
                <a:srgbClr val="7f7f7f"/>
              </a:solidFill>
              <a:miter/>
            </a:ln>
          </p:spPr>
        </p:pic>
        <p:sp>
          <p:nvSpPr>
            <p:cNvPr id="47" name="CasellaDiTesto 40"/>
            <p:cNvSpPr/>
            <p:nvPr/>
          </p:nvSpPr>
          <p:spPr>
            <a:xfrm>
              <a:off x="4418640" y="1156680"/>
              <a:ext cx="2563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Acetyl NF-kB p65 (Lys 310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3" descr="C:\Users\dora\Desktop\VALENTINA\2015\Immagini dal ChemiDoc\TIFF 27-01-2015\G1 ph-SIRT G2 GAPDH 10'.tif"/>
            <p:cNvPicPr/>
            <p:nvPr/>
          </p:nvPicPr>
          <p:blipFill>
            <a:blip r:embed="rId3">
              <a:lum bright="-10000"/>
            </a:blip>
            <a:srcRect l="27493" t="36010" r="27974" b="55606"/>
            <a:stretch/>
          </p:blipFill>
          <p:spPr>
            <a:xfrm>
              <a:off x="1704600" y="1523880"/>
              <a:ext cx="2529000" cy="344160"/>
            </a:xfrm>
            <a:prstGeom prst="rect">
              <a:avLst/>
            </a:prstGeom>
            <a:ln w="9360">
              <a:solidFill>
                <a:srgbClr val="7f7f7f"/>
              </a:solidFill>
              <a:miter/>
            </a:ln>
          </p:spPr>
        </p:pic>
        <p:sp>
          <p:nvSpPr>
            <p:cNvPr id="49" name="Rettangolo 47"/>
            <p:cNvSpPr/>
            <p:nvPr/>
          </p:nvSpPr>
          <p:spPr>
            <a:xfrm>
              <a:off x="4275360" y="1528560"/>
              <a:ext cx="1741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NF-kB p65 (65kDa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Parentesi graffa aperta 48"/>
            <p:cNvSpPr/>
            <p:nvPr/>
          </p:nvSpPr>
          <p:spPr>
            <a:xfrm rot="16200000">
              <a:off x="2209320" y="1656720"/>
              <a:ext cx="115560" cy="652320"/>
            </a:xfrm>
            <a:custGeom>
              <a:avLst/>
              <a:gdLst>
                <a:gd name="textAreaLeft" fmla="*/ 73800 w 115560"/>
                <a:gd name="textAreaRight" fmla="*/ 115920 w 115560"/>
                <a:gd name="textAreaTop" fmla="*/ 2880 h 652320"/>
                <a:gd name="textAreaBottom" fmla="*/ 649440 h 65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65"/>
                    <a:pt x="10800" y="330"/>
                  </a:cubicBezTo>
                  <a:lnTo>
                    <a:pt x="10800" y="10470"/>
                  </a:lnTo>
                  <a:cubicBezTo>
                    <a:pt x="10800" y="10635"/>
                    <a:pt x="5400" y="10800"/>
                    <a:pt x="0" y="10800"/>
                  </a:cubicBezTo>
                  <a:cubicBezTo>
                    <a:pt x="5400" y="10800"/>
                    <a:pt x="10800" y="10965"/>
                    <a:pt x="10800" y="11130"/>
                  </a:cubicBezTo>
                  <a:lnTo>
                    <a:pt x="10800" y="21270"/>
                  </a:lnTo>
                  <a:cubicBezTo>
                    <a:pt x="10800" y="21435"/>
                    <a:pt x="162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Parentesi graffa aperta 49"/>
            <p:cNvSpPr/>
            <p:nvPr/>
          </p:nvSpPr>
          <p:spPr>
            <a:xfrm rot="16200000">
              <a:off x="2947680" y="1656720"/>
              <a:ext cx="115560" cy="652320"/>
            </a:xfrm>
            <a:custGeom>
              <a:avLst/>
              <a:gdLst>
                <a:gd name="textAreaLeft" fmla="*/ 73800 w 115560"/>
                <a:gd name="textAreaRight" fmla="*/ 115920 w 115560"/>
                <a:gd name="textAreaTop" fmla="*/ 2880 h 652320"/>
                <a:gd name="textAreaBottom" fmla="*/ 649440 h 65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65"/>
                    <a:pt x="10800" y="330"/>
                  </a:cubicBezTo>
                  <a:lnTo>
                    <a:pt x="10800" y="10470"/>
                  </a:lnTo>
                  <a:cubicBezTo>
                    <a:pt x="10800" y="10635"/>
                    <a:pt x="5400" y="10800"/>
                    <a:pt x="0" y="10800"/>
                  </a:cubicBezTo>
                  <a:cubicBezTo>
                    <a:pt x="5400" y="10800"/>
                    <a:pt x="10800" y="10965"/>
                    <a:pt x="10800" y="11130"/>
                  </a:cubicBezTo>
                  <a:lnTo>
                    <a:pt x="10800" y="21270"/>
                  </a:lnTo>
                  <a:cubicBezTo>
                    <a:pt x="10800" y="21435"/>
                    <a:pt x="162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Parentesi graffa aperta 50"/>
            <p:cNvSpPr/>
            <p:nvPr/>
          </p:nvSpPr>
          <p:spPr>
            <a:xfrm rot="16200000">
              <a:off x="3692160" y="1656720"/>
              <a:ext cx="115560" cy="652320"/>
            </a:xfrm>
            <a:custGeom>
              <a:avLst/>
              <a:gdLst>
                <a:gd name="textAreaLeft" fmla="*/ 73800 w 115560"/>
                <a:gd name="textAreaRight" fmla="*/ 115920 w 115560"/>
                <a:gd name="textAreaTop" fmla="*/ 2880 h 652320"/>
                <a:gd name="textAreaBottom" fmla="*/ 649440 h 65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65"/>
                    <a:pt x="10800" y="330"/>
                  </a:cubicBezTo>
                  <a:lnTo>
                    <a:pt x="10800" y="10470"/>
                  </a:lnTo>
                  <a:cubicBezTo>
                    <a:pt x="10800" y="10635"/>
                    <a:pt x="5400" y="10800"/>
                    <a:pt x="0" y="10800"/>
                  </a:cubicBezTo>
                  <a:cubicBezTo>
                    <a:pt x="5400" y="10800"/>
                    <a:pt x="10800" y="10965"/>
                    <a:pt x="10800" y="11130"/>
                  </a:cubicBezTo>
                  <a:lnTo>
                    <a:pt x="10800" y="21270"/>
                  </a:lnTo>
                  <a:cubicBezTo>
                    <a:pt x="10800" y="21435"/>
                    <a:pt x="162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Picture 9" descr="C:\Users\dora\Desktop\VALENTINA\2015\Immagini dal ChemiDoc\TIFF 24-03-2015\G1 SIRT1 ph-p65 ph-IKBalpha 15'.tif"/>
            <p:cNvPicPr/>
            <p:nvPr/>
          </p:nvPicPr>
          <p:blipFill>
            <a:blip r:embed="rId4"/>
            <a:srcRect l="20977" t="19240" r="20115" b="71154"/>
            <a:stretch/>
          </p:blipFill>
          <p:spPr>
            <a:xfrm>
              <a:off x="1557000" y="3597480"/>
              <a:ext cx="3645720" cy="429840"/>
            </a:xfrm>
            <a:prstGeom prst="rect">
              <a:avLst/>
            </a:prstGeom>
            <a:ln w="9360">
              <a:solidFill>
                <a:srgbClr val="7f7f7f"/>
              </a:solidFill>
              <a:miter/>
            </a:ln>
          </p:spPr>
        </p:pic>
        <p:sp>
          <p:nvSpPr>
            <p:cNvPr id="54" name="Rectangle 50"/>
            <p:cNvSpPr/>
            <p:nvPr/>
          </p:nvSpPr>
          <p:spPr>
            <a:xfrm>
              <a:off x="1857240" y="4360320"/>
              <a:ext cx="28728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I/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51"/>
            <p:cNvSpPr/>
            <p:nvPr/>
          </p:nvSpPr>
          <p:spPr>
            <a:xfrm>
              <a:off x="2867400" y="4360320"/>
              <a:ext cx="2840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A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53"/>
            <p:cNvSpPr/>
            <p:nvPr/>
          </p:nvSpPr>
          <p:spPr>
            <a:xfrm>
              <a:off x="3915360" y="4360320"/>
              <a:ext cx="372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RSV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Parentesi graffa aperta 31"/>
            <p:cNvSpPr/>
            <p:nvPr/>
          </p:nvSpPr>
          <p:spPr>
            <a:xfrm rot="16200000">
              <a:off x="1972800" y="3918960"/>
              <a:ext cx="115560" cy="652320"/>
            </a:xfrm>
            <a:custGeom>
              <a:avLst/>
              <a:gdLst>
                <a:gd name="textAreaLeft" fmla="*/ 73800 w 115560"/>
                <a:gd name="textAreaRight" fmla="*/ 115920 w 115560"/>
                <a:gd name="textAreaTop" fmla="*/ 2880 h 652320"/>
                <a:gd name="textAreaBottom" fmla="*/ 649440 h 652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65"/>
                    <a:pt x="10800" y="330"/>
                  </a:cubicBezTo>
                  <a:lnTo>
                    <a:pt x="10800" y="10470"/>
                  </a:lnTo>
                  <a:cubicBezTo>
                    <a:pt x="10800" y="10635"/>
                    <a:pt x="5400" y="10800"/>
                    <a:pt x="0" y="10800"/>
                  </a:cubicBezTo>
                  <a:cubicBezTo>
                    <a:pt x="5400" y="10800"/>
                    <a:pt x="10800" y="10965"/>
                    <a:pt x="10800" y="11130"/>
                  </a:cubicBezTo>
                  <a:lnTo>
                    <a:pt x="10800" y="21270"/>
                  </a:lnTo>
                  <a:cubicBezTo>
                    <a:pt x="10800" y="21435"/>
                    <a:pt x="162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Parentesi graffa aperta 33"/>
            <p:cNvSpPr/>
            <p:nvPr/>
          </p:nvSpPr>
          <p:spPr>
            <a:xfrm rot="16200000">
              <a:off x="2935800" y="3726000"/>
              <a:ext cx="115560" cy="1038240"/>
            </a:xfrm>
            <a:custGeom>
              <a:avLst/>
              <a:gdLst>
                <a:gd name="textAreaLeft" fmla="*/ 73800 w 115560"/>
                <a:gd name="textAreaRight" fmla="*/ 115920 w 115560"/>
                <a:gd name="textAreaTop" fmla="*/ 2880 h 1038240"/>
                <a:gd name="textAreaBottom" fmla="*/ 1035360 h 1038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04"/>
                    <a:pt x="10800" y="208"/>
                  </a:cubicBezTo>
                  <a:lnTo>
                    <a:pt x="10800" y="10592"/>
                  </a:lnTo>
                  <a:cubicBezTo>
                    <a:pt x="10800" y="10696"/>
                    <a:pt x="5400" y="10800"/>
                    <a:pt x="0" y="10800"/>
                  </a:cubicBezTo>
                  <a:cubicBezTo>
                    <a:pt x="5400" y="10800"/>
                    <a:pt x="10800" y="10904"/>
                    <a:pt x="10800" y="11008"/>
                  </a:cubicBezTo>
                  <a:lnTo>
                    <a:pt x="10800" y="21392"/>
                  </a:lnTo>
                  <a:cubicBezTo>
                    <a:pt x="10800" y="21496"/>
                    <a:pt x="162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Parentesi graffa aperta 35"/>
            <p:cNvSpPr/>
            <p:nvPr/>
          </p:nvSpPr>
          <p:spPr>
            <a:xfrm rot="16200000">
              <a:off x="4062960" y="3726000"/>
              <a:ext cx="115560" cy="1038240"/>
            </a:xfrm>
            <a:custGeom>
              <a:avLst/>
              <a:gdLst>
                <a:gd name="textAreaLeft" fmla="*/ 73800 w 115560"/>
                <a:gd name="textAreaRight" fmla="*/ 115920 w 115560"/>
                <a:gd name="textAreaTop" fmla="*/ 2880 h 1038240"/>
                <a:gd name="textAreaBottom" fmla="*/ 1035360 h 1038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104"/>
                    <a:pt x="10800" y="208"/>
                  </a:cubicBezTo>
                  <a:lnTo>
                    <a:pt x="10800" y="10592"/>
                  </a:lnTo>
                  <a:cubicBezTo>
                    <a:pt x="10800" y="10696"/>
                    <a:pt x="5400" y="10800"/>
                    <a:pt x="0" y="10800"/>
                  </a:cubicBezTo>
                  <a:cubicBezTo>
                    <a:pt x="5400" y="10800"/>
                    <a:pt x="10800" y="10904"/>
                    <a:pt x="10800" y="11008"/>
                  </a:cubicBezTo>
                  <a:lnTo>
                    <a:pt x="10800" y="21392"/>
                  </a:lnTo>
                  <a:cubicBezTo>
                    <a:pt x="10800" y="21496"/>
                    <a:pt x="162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CasellaDiTesto 37"/>
            <p:cNvSpPr/>
            <p:nvPr/>
          </p:nvSpPr>
          <p:spPr>
            <a:xfrm>
              <a:off x="1877760" y="771480"/>
              <a:ext cx="2119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1       2     3     4     5       6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CasellaDiTesto 39"/>
            <p:cNvSpPr/>
            <p:nvPr/>
          </p:nvSpPr>
          <p:spPr>
            <a:xfrm>
              <a:off x="1836000" y="2803320"/>
              <a:ext cx="28720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1       2     3      4      5      6     7      8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CasellaDiTesto 40"/>
            <p:cNvSpPr/>
            <p:nvPr/>
          </p:nvSpPr>
          <p:spPr>
            <a:xfrm>
              <a:off x="1071720" y="476280"/>
              <a:ext cx="21772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Calibri"/>
                </a:rPr>
                <a:t>A. Immunoblotting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CasellaDiTesto 41"/>
            <p:cNvSpPr/>
            <p:nvPr/>
          </p:nvSpPr>
          <p:spPr>
            <a:xfrm>
              <a:off x="972000" y="2401920"/>
              <a:ext cx="27640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000" spc="-1" strike="noStrike">
                  <a:solidFill>
                    <a:srgbClr val="000000"/>
                  </a:solidFill>
                  <a:latin typeface="Calibri"/>
                </a:rPr>
                <a:t>B. Immunoprecipitation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CasellaDiTesto 40"/>
            <p:cNvSpPr/>
            <p:nvPr/>
          </p:nvSpPr>
          <p:spPr>
            <a:xfrm>
              <a:off x="5249880" y="3364920"/>
              <a:ext cx="2562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Acetyl NF-kB p65 (Lys 310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ttangolo 47"/>
            <p:cNvSpPr/>
            <p:nvPr/>
          </p:nvSpPr>
          <p:spPr>
            <a:xfrm>
              <a:off x="5105880" y="3681000"/>
              <a:ext cx="17413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NF-kB p65 (65kDa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Rettangolo 47"/>
          <p:cNvSpPr/>
          <p:nvPr/>
        </p:nvSpPr>
        <p:spPr>
          <a:xfrm>
            <a:off x="250920" y="44280"/>
            <a:ext cx="6481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Potenza et al, S3 fig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ttangolo 29"/>
          <p:cNvSpPr/>
          <p:nvPr/>
        </p:nvSpPr>
        <p:spPr>
          <a:xfrm>
            <a:off x="250920" y="4724280"/>
            <a:ext cx="8497800" cy="204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Calibri"/>
              </a:rPr>
              <a:t>Protein acetylation levels in heart lysates.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Fifteen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 (15) minutes after reperfusion, hearts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rom I/R, RSV and AD groups were prepared using lysis buffer, and samples then subjected to immunoblotting (A) or immunoprecipitation (B), according to standard methods. 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: Samples were separated by 8% SDS-PAGE followed by immunoblotting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with anti-acetyl NF-kB p65 </a:t>
            </a:r>
            <a:r>
              <a:rPr b="0" lang="it-IT" sz="1600" spc="-1" strike="noStrike" baseline="30000">
                <a:solidFill>
                  <a:srgbClr val="000000"/>
                </a:solidFill>
                <a:latin typeface="Calibri"/>
              </a:rPr>
              <a:t>(Lys310)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antibody (Cell Signaling). </a:t>
            </a:r>
            <a:r>
              <a:rPr b="1" lang="it-IT" sz="1600" spc="-1" strike="noStrike">
                <a:solidFill>
                  <a:srgbClr val="000000"/>
                </a:solidFill>
                <a:latin typeface="Calibri"/>
              </a:rPr>
              <a:t>B.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 Lysates were first immunoprecipitated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using an antibody against NF-kB p65 (1:50, Cell Signaling), and then subjected to immunoblotting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with anti-acetyl NF-kB p65 </a:t>
            </a:r>
            <a:r>
              <a:rPr b="0" lang="it-IT" sz="1600" spc="-1" strike="noStrike" baseline="30000">
                <a:solidFill>
                  <a:srgbClr val="000000"/>
                </a:solidFill>
                <a:latin typeface="Calibri"/>
              </a:rPr>
              <a:t>(Lys310) </a:t>
            </a:r>
            <a:r>
              <a:rPr b="0" lang="it-IT" sz="1600" spc="-1" strike="noStrike">
                <a:solidFill>
                  <a:srgbClr val="000000"/>
                </a:solidFill>
                <a:latin typeface="Calibri"/>
              </a:rPr>
              <a:t>antibody (Cell Signaling). A representative blot is shown for triplicate experiments. Qualitatively, acetylation levels on NF-kB p65 (at Lys 310) appear slightly decreased in both RSV and AD groups with respect to I/R group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0-15T11:29:27Z</dcterms:created>
  <dc:creator>Monica</dc:creator>
  <dc:description/>
  <dc:language>en-US</dc:language>
  <cp:lastModifiedBy>Monica</cp:lastModifiedBy>
  <dcterms:modified xsi:type="dcterms:W3CDTF">2018-10-30T11:58:51Z</dcterms:modified>
  <cp:revision>8</cp:revision>
  <dc:subject/>
  <dc:title>Diapositiva 1</dc:title>
</cp:coreProperties>
</file>